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ct" ContentType="image/x-pict"/>
  <Override PartName="/ppt/media/image6.png" ContentType="image/png"/>
  <Override PartName="/ppt/media/image4.pct" ContentType="image/x-pict"/>
  <Override PartName="/ppt/media/image5.png" ContentType="image/png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F1D435-CADD-4A62-847B-AE9BDC9DB0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3070B5-75F5-4989-84D4-7BED0E42D3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C58CF-43F5-4320-9C4B-9865B98A42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3BB32-66B3-40BF-A9AF-EC16E34319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25722-DDDB-4DDC-9D8D-B33B76FB7C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36B330-BC74-4557-B76A-F100648EDD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77AF7-D9AF-4113-AC4A-273963ACF7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C563D8-2118-4772-85EA-4EF72A1451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A67578-F433-4059-AA30-AB070B297A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33F909-1F98-472A-A7C2-807A8CC491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B33C9-D4D7-4CC4-AACC-2F8D42237C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12272-8EBF-45B6-A04A-6A631BC973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2D9999-931E-4DFB-8FD2-C8281312B81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Base" hidden="1"/>
          <p:cNvSpPr/>
          <p:nvPr/>
        </p:nvSpPr>
        <p:spPr>
          <a:xfrm>
            <a:off x="1523880" y="1397160"/>
            <a:ext cx="6096240" cy="40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.pct"/><Relationship Id="rId3" Type="http://schemas.openxmlformats.org/officeDocument/2006/relationships/package" Target="../embeddings/oleObject2.xlsx"/><Relationship Id="rId4" Type="http://schemas.openxmlformats.org/officeDocument/2006/relationships/image" Target="../media/image4.pct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" descr=""/>
          <p:cNvPicPr/>
          <p:nvPr/>
        </p:nvPicPr>
        <p:blipFill>
          <a:blip r:embed="rId1"/>
          <a:srcRect l="0" t="0" r="39582" b="0"/>
          <a:stretch/>
        </p:blipFill>
        <p:spPr>
          <a:xfrm>
            <a:off x="0" y="609480"/>
            <a:ext cx="1905120" cy="60962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2286000" y="228600"/>
            <a:ext cx="6648480" cy="594360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447920" y="5943600"/>
            <a:ext cx="76960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upplemental Figure S1: Diagram to show previously reported interactions between EGFR and 23 other Egr1 target genes using Pathway Studio, Ariadne In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"/>
          <p:cNvGraphicFramePr/>
          <p:nvPr/>
        </p:nvGraphicFramePr>
        <p:xfrm>
          <a:off x="3352680" y="533520"/>
          <a:ext cx="3753000" cy="25430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352680" y="533520"/>
                    <a:ext cx="3753000" cy="2543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3352680" y="3124080"/>
          <a:ext cx="3733920" cy="21322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352680" y="3124080"/>
                    <a:ext cx="3733920" cy="213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"/>
          <p:cNvSpPr/>
          <p:nvPr/>
        </p:nvSpPr>
        <p:spPr>
          <a:xfrm>
            <a:off x="76320" y="5334120"/>
            <a:ext cx="90676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upplemental Figure S2: Plot showing the distribution of Fold change values from Affymetrix gene expression data and M values from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ヒラギノ角ゴ ProN W3"/>
              </a:rPr>
              <a:t>C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h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IP on chip data for Egr1 target gen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631480" y="533520"/>
            <a:ext cx="1460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=0.68,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0.0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rcRect l="0" t="-2211" r="6316" b="6669"/>
          <a:stretch/>
        </p:blipFill>
        <p:spPr>
          <a:xfrm>
            <a:off x="2666880" y="0"/>
            <a:ext cx="5867640" cy="579132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2"/>
          <a:srcRect l="0" t="0" r="39582" b="0"/>
          <a:stretch/>
        </p:blipFill>
        <p:spPr>
          <a:xfrm>
            <a:off x="0" y="609480"/>
            <a:ext cx="1905120" cy="609624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1523880" y="6019920"/>
            <a:ext cx="73915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upplemental Figure S3: Diagram to show previously reported interactions between Egr1 its target genes using Pathway Studio, Ariadne In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609480" y="182520"/>
            <a:ext cx="8420400" cy="568476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152280" y="5486400"/>
            <a:ext cx="8991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upplemental Figure S4: Gene expression of p53, p73, TGFb1 and PTEN was studied by qRT-PCR analysis of RNA isolated from M12 cells at various time points after UV-C treatment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875560" y="4052880"/>
            <a:ext cx="2885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ime After UV-C treatmen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800600" y="4038480"/>
            <a:ext cx="685800" cy="304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8T19:24:28Z</dcterms:created>
  <dc:creator>aroras</dc:creator>
  <dc:description/>
  <dc:language>en-US</dc:language>
  <cp:lastModifiedBy>Shilpi Arora</cp:lastModifiedBy>
  <dcterms:modified xsi:type="dcterms:W3CDTF">2008-11-17T02:53:16Z</dcterms:modified>
  <cp:revision>51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uthorEmail">
    <vt:lpwstr>dmercola@uci.edu</vt:lpwstr>
  </property>
  <property fmtid="{D5CDD505-2E9C-101B-9397-08002B2CF9AE}" pid="3" name="_AuthorEmailDisplayName">
    <vt:lpwstr>Mercola, Dan</vt:lpwstr>
  </property>
  <property fmtid="{D5CDD505-2E9C-101B-9397-08002B2CF9AE}" pid="4" name="_EmailSubject">
    <vt:lpwstr>Please review 'figure legends12_19 short'</vt:lpwstr>
  </property>
  <property fmtid="{D5CDD505-2E9C-101B-9397-08002B2CF9AE}" pid="5" name="_NewReviewCycle">
    <vt:lpwstr/>
  </property>
  <property fmtid="{D5CDD505-2E9C-101B-9397-08002B2CF9AE}" pid="6" name="_ReviewCycleID">
    <vt:r8>-698082550</vt:r8>
  </property>
  <property fmtid="{D5CDD505-2E9C-101B-9397-08002B2CF9AE}" pid="7" name="_ReviewingToolsShownOnce">
    <vt:lpwstr/>
  </property>
  <property fmtid="{D5CDD505-2E9C-101B-9397-08002B2CF9AE}" pid="8" name="_TentativeReviewCycleID">
    <vt:r8>-698082550</vt:r8>
  </property>
</Properties>
</file>